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3" r:id="rId2"/>
    <p:sldId id="29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Hyperopia" id="{0969E8EA-A673-AA43-B389-AD02B16A0247}">
          <p14:sldIdLst>
            <p14:sldId id="293"/>
            <p14:sldId id="29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pos="5019" userDrawn="1">
          <p15:clr>
            <a:srgbClr val="A4A3A4"/>
          </p15:clr>
        </p15:guide>
        <p15:guide id="4" pos="75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C18E7F-B5D8-1F4D-BB1C-F53D9C458B5B}" v="5" dt="2024-08-27T08:06:55.7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1" d="100"/>
          <a:sy n="81" d="100"/>
        </p:scale>
        <p:origin x="84" y="140"/>
      </p:cViewPr>
      <p:guideLst>
        <p:guide orient="horz" pos="2160"/>
        <p:guide pos="3840"/>
        <p:guide pos="5019"/>
        <p:guide pos="75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900113" cy="900113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5115A6-4AD4-42C2-4558-C80641B09D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FA6F3F-F858-9879-8BE4-E0D2D45E06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78BAE4-74AC-9F74-1026-BF566794E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6FA97C-7A6B-5235-F1FB-866A759D8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2186A-75A5-6F4A-E499-98BC3D76D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81094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C54DE0-A18A-BF8A-02A3-8D6F1A0B9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2BCB0E-2C33-66CA-0174-B91029E993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76706-106D-EA51-B34F-59391B5FE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4F882B-02E0-85DD-EA6A-21D35A0CE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F7E62-D854-BE45-7A7D-F91E56316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9640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DF5FF0F-3F3B-B08B-8517-959A144CAA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0AC674-014A-547B-5753-A0B4127DE6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BCFE7-C0F6-44C0-B075-EFDE65EB0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C77597-63E2-B765-1A3F-91039CC8A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420617-1E41-881D-11FC-52B65BCA3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0C82DF-85E8-A1FF-721D-0F91B4B83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781788-E569-2976-2ECC-AB4218236F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BB242-24E9-DDA6-80BD-20D416D2E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E27C1D-8CDC-F1B4-326D-E15E7C42F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AEABEB-681D-02C7-F6B9-5DD162809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597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FE92BF-696B-F288-1E62-BCFDE6CF3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199255-F495-E8AA-794D-1B19220C44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175A0-1791-9C3F-92E5-4A6D5AB07D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1A432-AA20-CA8E-7B6C-A5CDF9417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7517A-2212-A5C1-F185-E37E6D038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655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1902D-4608-F418-5B0D-BD32D80E2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24721-5A1E-ADEA-7F8E-611FF81D9B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EB8D5A-D9A8-2141-D7AB-3A2CDC824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B19C3A-0244-C9EE-9933-C263F1CBB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7AD71-7CF4-B577-6428-D3B2409BB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207ABC-0002-E1EF-F82D-67A9EEC5F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520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6043C6-EF55-C9A1-341D-922902644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16A87-01D9-58AB-EBEE-55490AFB3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027A6C-6A48-5A29-37ED-AE7B353C2C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7BED5B-5D44-D730-D881-7A3387C18C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A138AF-1C79-1385-7450-B634F87B54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5241ED-4A92-916B-8AA9-D0D836F33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4B2203-EE3F-2801-FA5B-3383155F4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49E334-604E-9220-3C71-F5B120C37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068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41CB91-65D8-C601-ACE0-09BD77266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A199E4E-5CCD-D8A3-41DD-38E74CA63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C21506-9895-23DE-D005-8AB627F46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9ACED2-C1B4-A5FB-7852-9B47D0599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1679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3B0AB8-8B5E-B917-E7DB-6B6D199B4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20FEBF-FC09-75D1-CF58-183D8D5129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5867A6-AC50-7AA0-C633-D54EBBF0C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559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CF12B-932B-2DDD-E42D-ABD972DB1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F3E617-12F3-59FE-10EF-9BD43C335F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CFCFC6-46F7-E984-3E2C-A0B8BA616B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5A06F0-9AB4-56BF-F5B6-5015DF5B5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5F4850-2C75-F9D4-D8DC-403CCE73C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FC9005-F81A-8D78-16AC-95380A412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984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A94874-71D0-364D-6DDE-702A878AD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7B6FD7-E7A7-9A07-1233-7B01602633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CF216D-F379-746D-38BB-35266ECE05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DC6530-E729-8FC0-A0E9-20308DAEE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619B72-0E3B-0B3E-608A-8E593CD5A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3CA04A-4AFE-F5AE-B20A-E75B3B799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729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741008-CFDC-B271-ABFD-D59B332B7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B2A9F8-342C-1238-92F6-B35D24595E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C5298-81BD-4C5D-DD10-7FA4143940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434533-289E-7747-AB2A-09ABDB9FDE72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3DE247-8C8A-83C6-19A7-19084BFB0B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C162BF-50A9-DFD6-27D7-7EFD301DB4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D3652C-F831-744D-AA24-64977561193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536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C7126C6-E2FA-5588-6CC9-A7A1E7BF272B}"/>
              </a:ext>
            </a:extLst>
          </p:cNvPr>
          <p:cNvSpPr txBox="1"/>
          <p:nvPr/>
        </p:nvSpPr>
        <p:spPr>
          <a:xfrm>
            <a:off x="5544350" y="3857321"/>
            <a:ext cx="6647650" cy="258532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/>
              <a:t>Figures: proportion of the population tested each year with RE SER ≥ 0.5 D, ≥4D and equal to 0D.  </a:t>
            </a:r>
          </a:p>
          <a:p>
            <a:r>
              <a:rPr lang="en-GB" dirty="0"/>
              <a:t>Note: the lower year is shown on the x-axis.  This can be changed from 2013 -&gt; 2013-14 if we wish to use this figure.</a:t>
            </a:r>
          </a:p>
          <a:p>
            <a:endParaRPr lang="en-GB" dirty="0"/>
          </a:p>
          <a:p>
            <a:r>
              <a:rPr lang="en-GB" dirty="0"/>
              <a:t>Have included change in </a:t>
            </a:r>
            <a:r>
              <a:rPr lang="en-GB" dirty="0" err="1"/>
              <a:t>plano’s</a:t>
            </a:r>
            <a:r>
              <a:rPr lang="en-GB" dirty="0"/>
              <a:t> for personal interest.</a:t>
            </a:r>
          </a:p>
          <a:p>
            <a:endParaRPr lang="en-GB" dirty="0"/>
          </a:p>
          <a:p>
            <a:r>
              <a:rPr lang="en-GB" dirty="0"/>
              <a:t>Data : ‘S4S2 all years raw, for paper 2.xlsx’</a:t>
            </a:r>
          </a:p>
          <a:p>
            <a:r>
              <a:rPr lang="en-GB" dirty="0"/>
              <a:t>’Myopia over time’ sheet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1E0125A-E347-B741-9FCB-CC5BC080B27E}"/>
              </a:ext>
            </a:extLst>
          </p:cNvPr>
          <p:cNvSpPr txBox="1"/>
          <p:nvPr/>
        </p:nvSpPr>
        <p:spPr>
          <a:xfrm>
            <a:off x="301354" y="129110"/>
            <a:ext cx="37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1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F8F6FD-D27F-EED1-64D5-A389688FB109}"/>
              </a:ext>
            </a:extLst>
          </p:cNvPr>
          <p:cNvSpPr txBox="1"/>
          <p:nvPr/>
        </p:nvSpPr>
        <p:spPr>
          <a:xfrm>
            <a:off x="301354" y="352001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2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C264D27-C278-BAF8-5DD8-96B3B2F99902}"/>
              </a:ext>
            </a:extLst>
          </p:cNvPr>
          <p:cNvSpPr txBox="1"/>
          <p:nvPr/>
        </p:nvSpPr>
        <p:spPr>
          <a:xfrm>
            <a:off x="6593964" y="12911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3.</a:t>
            </a:r>
          </a:p>
        </p:txBody>
      </p:sp>
      <p:pic>
        <p:nvPicPr>
          <p:cNvPr id="3" name="Picture 2" descr="A graph with numbers and lines&#10;&#10;Description automatically generated">
            <a:extLst>
              <a:ext uri="{FF2B5EF4-FFF2-40B4-BE49-F238E27FC236}">
                <a16:creationId xmlns:a16="http://schemas.microsoft.com/office/drawing/2014/main" id="{870C9578-65D7-92BD-DCF2-EE8C989D6537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3259" y="17042"/>
            <a:ext cx="4771091" cy="3407922"/>
          </a:xfrm>
          <a:prstGeom prst="rect">
            <a:avLst/>
          </a:prstGeom>
        </p:spPr>
      </p:pic>
      <p:pic>
        <p:nvPicPr>
          <p:cNvPr id="9" name="Picture 8" descr="A graph with numbers and a line&#10;&#10;Description automatically generated">
            <a:extLst>
              <a:ext uri="{FF2B5EF4-FFF2-40B4-BE49-F238E27FC236}">
                <a16:creationId xmlns:a16="http://schemas.microsoft.com/office/drawing/2014/main" id="{F0EE441C-2E0C-F4BC-74A2-624873E7F507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042427" y="0"/>
            <a:ext cx="4771091" cy="3407922"/>
          </a:xfrm>
          <a:prstGeom prst="rect">
            <a:avLst/>
          </a:prstGeom>
        </p:spPr>
      </p:pic>
      <p:pic>
        <p:nvPicPr>
          <p:cNvPr id="12" name="Picture 11" descr="A graph with numbers and a line&#10;&#10;Description automatically generated">
            <a:extLst>
              <a:ext uri="{FF2B5EF4-FFF2-40B4-BE49-F238E27FC236}">
                <a16:creationId xmlns:a16="http://schemas.microsoft.com/office/drawing/2014/main" id="{F51D6DAA-B860-514F-3BD7-6A58947DC207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3259" y="3446022"/>
            <a:ext cx="4771091" cy="3407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7220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3521899-5821-CA78-77AB-880792F19E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8243615"/>
              </p:ext>
            </p:extLst>
          </p:nvPr>
        </p:nvGraphicFramePr>
        <p:xfrm>
          <a:off x="249846" y="170668"/>
          <a:ext cx="7040640" cy="2103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73440">
                  <a:extLst>
                    <a:ext uri="{9D8B030D-6E8A-4147-A177-3AD203B41FA5}">
                      <a16:colId xmlns:a16="http://schemas.microsoft.com/office/drawing/2014/main" val="3918528989"/>
                    </a:ext>
                  </a:extLst>
                </a:gridCol>
                <a:gridCol w="1173440">
                  <a:extLst>
                    <a:ext uri="{9D8B030D-6E8A-4147-A177-3AD203B41FA5}">
                      <a16:colId xmlns:a16="http://schemas.microsoft.com/office/drawing/2014/main" val="2819853971"/>
                    </a:ext>
                  </a:extLst>
                </a:gridCol>
                <a:gridCol w="1173440">
                  <a:extLst>
                    <a:ext uri="{9D8B030D-6E8A-4147-A177-3AD203B41FA5}">
                      <a16:colId xmlns:a16="http://schemas.microsoft.com/office/drawing/2014/main" val="1940589141"/>
                    </a:ext>
                  </a:extLst>
                </a:gridCol>
                <a:gridCol w="1173440">
                  <a:extLst>
                    <a:ext uri="{9D8B030D-6E8A-4147-A177-3AD203B41FA5}">
                      <a16:colId xmlns:a16="http://schemas.microsoft.com/office/drawing/2014/main" val="2647731457"/>
                    </a:ext>
                  </a:extLst>
                </a:gridCol>
                <a:gridCol w="1173440">
                  <a:extLst>
                    <a:ext uri="{9D8B030D-6E8A-4147-A177-3AD203B41FA5}">
                      <a16:colId xmlns:a16="http://schemas.microsoft.com/office/drawing/2014/main" val="850883064"/>
                    </a:ext>
                  </a:extLst>
                </a:gridCol>
                <a:gridCol w="1173440">
                  <a:extLst>
                    <a:ext uri="{9D8B030D-6E8A-4147-A177-3AD203B41FA5}">
                      <a16:colId xmlns:a16="http://schemas.microsoft.com/office/drawing/2014/main" val="3248631981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</a:rPr>
                        <a:t>RE SER values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27412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Yea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≤ -0.5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-0.49 to -0.01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(inclusive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(-0.009 to 0.009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0.01 to 4.00</a:t>
                      </a:r>
                      <a:br>
                        <a:rPr lang="en-GB" sz="1200" u="none" strike="noStrike" dirty="0">
                          <a:effectLst/>
                        </a:rPr>
                      </a:br>
                      <a:r>
                        <a:rPr lang="en-GB" sz="1200" u="none" strike="noStrike" dirty="0">
                          <a:effectLst/>
                        </a:rPr>
                        <a:t>(inclusive)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≥ 4.0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69793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1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.40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.32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.60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0.83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1.84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22009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.29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.53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0.49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7.31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2.38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72533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1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.72%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.49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.65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9.76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2.38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60273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2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1.51%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.63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4.92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69.24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0.70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17238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10.65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.47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.85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72.43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9.59%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5508736"/>
                  </a:ext>
                </a:extLst>
              </a:tr>
            </a:tbl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6DE6B0D1-B11F-A40E-7E34-A86C5A8A6A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7076" y="2482363"/>
            <a:ext cx="5588000" cy="4203700"/>
          </a:xfrm>
          <a:prstGeom prst="rect">
            <a:avLst/>
          </a:prstGeom>
        </p:spPr>
      </p:pic>
      <p:pic>
        <p:nvPicPr>
          <p:cNvPr id="16" name="Picture 15" descr="A screenshot of a graph&#10;&#10;Description automatically generated">
            <a:extLst>
              <a:ext uri="{FF2B5EF4-FFF2-40B4-BE49-F238E27FC236}">
                <a16:creationId xmlns:a16="http://schemas.microsoft.com/office/drawing/2014/main" id="{BAC9ED8A-21ED-8595-BAD5-E35A557A77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20000" y="0"/>
            <a:ext cx="457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102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172</Words>
  <Application>Microsoft Office PowerPoint</Application>
  <PresentationFormat>Widescreen</PresentationFormat>
  <Paragraphs>4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jamin Evans</dc:creator>
  <cp:lastModifiedBy>Mark Rosenfield</cp:lastModifiedBy>
  <cp:revision>2</cp:revision>
  <dcterms:created xsi:type="dcterms:W3CDTF">2024-08-11T16:34:56Z</dcterms:created>
  <dcterms:modified xsi:type="dcterms:W3CDTF">2024-09-25T10:07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06c24981-b6df-48f8-949b-0896357b9b03_Enabled">
    <vt:lpwstr>true</vt:lpwstr>
  </property>
  <property fmtid="{D5CDD505-2E9C-101B-9397-08002B2CF9AE}" pid="3" name="MSIP_Label_06c24981-b6df-48f8-949b-0896357b9b03_SetDate">
    <vt:lpwstr>2024-08-11T16:36:36Z</vt:lpwstr>
  </property>
  <property fmtid="{D5CDD505-2E9C-101B-9397-08002B2CF9AE}" pid="4" name="MSIP_Label_06c24981-b6df-48f8-949b-0896357b9b03_Method">
    <vt:lpwstr>Standard</vt:lpwstr>
  </property>
  <property fmtid="{D5CDD505-2E9C-101B-9397-08002B2CF9AE}" pid="5" name="MSIP_Label_06c24981-b6df-48f8-949b-0896357b9b03_Name">
    <vt:lpwstr>Official</vt:lpwstr>
  </property>
  <property fmtid="{D5CDD505-2E9C-101B-9397-08002B2CF9AE}" pid="6" name="MSIP_Label_06c24981-b6df-48f8-949b-0896357b9b03_SiteId">
    <vt:lpwstr>dd615949-5bd0-4da0-ac52-28ef8d336373</vt:lpwstr>
  </property>
  <property fmtid="{D5CDD505-2E9C-101B-9397-08002B2CF9AE}" pid="7" name="MSIP_Label_06c24981-b6df-48f8-949b-0896357b9b03_ActionId">
    <vt:lpwstr>223edce3-2fbe-4dd7-9532-4fd3c8243481</vt:lpwstr>
  </property>
  <property fmtid="{D5CDD505-2E9C-101B-9397-08002B2CF9AE}" pid="8" name="MSIP_Label_06c24981-b6df-48f8-949b-0896357b9b03_ContentBits">
    <vt:lpwstr>0</vt:lpwstr>
  </property>
</Properties>
</file>